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>
        <p:scale>
          <a:sx n="66" d="100"/>
          <a:sy n="66" d="100"/>
        </p:scale>
        <p:origin x="259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42269-E4A5-4A36-B19B-A06B564A564F}" type="datetimeFigureOut">
              <a:rPr lang="zh-CN" altLang="en-US" smtClean="0"/>
              <a:t>2019/1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557977-75B5-4B46-9239-8C8E8518A7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76101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42269-E4A5-4A36-B19B-A06B564A564F}" type="datetimeFigureOut">
              <a:rPr lang="zh-CN" altLang="en-US" smtClean="0"/>
              <a:t>2019/1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557977-75B5-4B46-9239-8C8E8518A7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54259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42269-E4A5-4A36-B19B-A06B564A564F}" type="datetimeFigureOut">
              <a:rPr lang="zh-CN" altLang="en-US" smtClean="0"/>
              <a:t>2019/1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557977-75B5-4B46-9239-8C8E8518A7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03573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42269-E4A5-4A36-B19B-A06B564A564F}" type="datetimeFigureOut">
              <a:rPr lang="zh-CN" altLang="en-US" smtClean="0"/>
              <a:t>2019/1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557977-75B5-4B46-9239-8C8E8518A7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97096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42269-E4A5-4A36-B19B-A06B564A564F}" type="datetimeFigureOut">
              <a:rPr lang="zh-CN" altLang="en-US" smtClean="0"/>
              <a:t>2019/1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557977-75B5-4B46-9239-8C8E8518A7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57835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42269-E4A5-4A36-B19B-A06B564A564F}" type="datetimeFigureOut">
              <a:rPr lang="zh-CN" altLang="en-US" smtClean="0"/>
              <a:t>2019/12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557977-75B5-4B46-9239-8C8E8518A7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22264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42269-E4A5-4A36-B19B-A06B564A564F}" type="datetimeFigureOut">
              <a:rPr lang="zh-CN" altLang="en-US" smtClean="0"/>
              <a:t>2019/12/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557977-75B5-4B46-9239-8C8E8518A7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47436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42269-E4A5-4A36-B19B-A06B564A564F}" type="datetimeFigureOut">
              <a:rPr lang="zh-CN" altLang="en-US" smtClean="0"/>
              <a:t>2019/12/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557977-75B5-4B46-9239-8C8E8518A7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10419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42269-E4A5-4A36-B19B-A06B564A564F}" type="datetimeFigureOut">
              <a:rPr lang="zh-CN" altLang="en-US" smtClean="0"/>
              <a:t>2019/12/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557977-75B5-4B46-9239-8C8E8518A7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53002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42269-E4A5-4A36-B19B-A06B564A564F}" type="datetimeFigureOut">
              <a:rPr lang="zh-CN" altLang="en-US" smtClean="0"/>
              <a:t>2019/12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557977-75B5-4B46-9239-8C8E8518A7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2835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42269-E4A5-4A36-B19B-A06B564A564F}" type="datetimeFigureOut">
              <a:rPr lang="zh-CN" altLang="en-US" smtClean="0"/>
              <a:t>2019/12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557977-75B5-4B46-9239-8C8E8518A7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64122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A42269-E4A5-4A36-B19B-A06B564A564F}" type="datetimeFigureOut">
              <a:rPr lang="zh-CN" altLang="en-US" smtClean="0"/>
              <a:t>2019/1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557977-75B5-4B46-9239-8C8E8518A7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35817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tiff"/><Relationship Id="rId13" Type="http://schemas.openxmlformats.org/officeDocument/2006/relationships/image" Target="../media/image16.tiff"/><Relationship Id="rId3" Type="http://schemas.openxmlformats.org/officeDocument/2006/relationships/image" Target="../media/image6.tiff"/><Relationship Id="rId7" Type="http://schemas.openxmlformats.org/officeDocument/2006/relationships/image" Target="../media/image10.tiff"/><Relationship Id="rId12" Type="http://schemas.openxmlformats.org/officeDocument/2006/relationships/image" Target="../media/image15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tiff"/><Relationship Id="rId11" Type="http://schemas.openxmlformats.org/officeDocument/2006/relationships/image" Target="../media/image14.tiff"/><Relationship Id="rId5" Type="http://schemas.openxmlformats.org/officeDocument/2006/relationships/image" Target="../media/image8.tiff"/><Relationship Id="rId10" Type="http://schemas.openxmlformats.org/officeDocument/2006/relationships/image" Target="../media/image13.tiff"/><Relationship Id="rId4" Type="http://schemas.openxmlformats.org/officeDocument/2006/relationships/image" Target="../media/image7.tiff"/><Relationship Id="rId9" Type="http://schemas.openxmlformats.org/officeDocument/2006/relationships/image" Target="../media/image12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tiff"/><Relationship Id="rId13" Type="http://schemas.openxmlformats.org/officeDocument/2006/relationships/image" Target="../media/image28.tiff"/><Relationship Id="rId3" Type="http://schemas.openxmlformats.org/officeDocument/2006/relationships/image" Target="../media/image18.tiff"/><Relationship Id="rId7" Type="http://schemas.openxmlformats.org/officeDocument/2006/relationships/image" Target="../media/image22.tiff"/><Relationship Id="rId12" Type="http://schemas.openxmlformats.org/officeDocument/2006/relationships/image" Target="../media/image27.tiff"/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tiff"/><Relationship Id="rId11" Type="http://schemas.openxmlformats.org/officeDocument/2006/relationships/image" Target="../media/image26.tiff"/><Relationship Id="rId5" Type="http://schemas.openxmlformats.org/officeDocument/2006/relationships/image" Target="../media/image20.tiff"/><Relationship Id="rId10" Type="http://schemas.openxmlformats.org/officeDocument/2006/relationships/image" Target="../media/image25.tiff"/><Relationship Id="rId4" Type="http://schemas.openxmlformats.org/officeDocument/2006/relationships/image" Target="../media/image19.tiff"/><Relationship Id="rId9" Type="http://schemas.openxmlformats.org/officeDocument/2006/relationships/image" Target="../media/image2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587387" y="1083795"/>
            <a:ext cx="26570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HCC97H-siNC</a:t>
            </a:r>
            <a:endParaRPr lang="zh-CN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3550838" y="1058801"/>
            <a:ext cx="3444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HCC97H-siCIRC</a:t>
            </a:r>
            <a:endParaRPr lang="zh-CN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568122" y="4061936"/>
            <a:ext cx="274452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Hep3B-scramble</a:t>
            </a:r>
            <a:endParaRPr lang="zh-CN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zh-CN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3523639" y="4091157"/>
            <a:ext cx="28392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Hep3B-CIRC</a:t>
            </a:r>
            <a:endParaRPr lang="zh-CN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"/>
          <p:cNvSpPr txBox="1"/>
          <p:nvPr/>
        </p:nvSpPr>
        <p:spPr>
          <a:xfrm>
            <a:off x="606731" y="570141"/>
            <a:ext cx="2657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3G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731" y="1579726"/>
            <a:ext cx="2743200" cy="2064882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0838" y="1579726"/>
            <a:ext cx="2743200" cy="2064882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731" y="4575967"/>
            <a:ext cx="2743200" cy="2064882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1671" y="4575967"/>
            <a:ext cx="2743200" cy="20648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139705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 rot="16200000">
            <a:off x="8088" y="1405978"/>
            <a:ext cx="13990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MHCC97H-siNC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 4"/>
          <p:cNvSpPr/>
          <p:nvPr/>
        </p:nvSpPr>
        <p:spPr>
          <a:xfrm rot="16200000">
            <a:off x="-100044" y="2961842"/>
            <a:ext cx="1615281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MHCC97H-siCIRC</a:t>
            </a:r>
            <a:endParaRPr lang="zh-CN" altLang="zh-CN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组合 5">
            <a:extLst>
              <a:ext uri="{FF2B5EF4-FFF2-40B4-BE49-F238E27FC236}">
                <a16:creationId xmlns:a16="http://schemas.microsoft.com/office/drawing/2014/main" id="{1F630888-F339-4132-A583-EEA0D00B27F0}"/>
              </a:ext>
            </a:extLst>
          </p:cNvPr>
          <p:cNvGrpSpPr/>
          <p:nvPr/>
        </p:nvGrpSpPr>
        <p:grpSpPr>
          <a:xfrm>
            <a:off x="950577" y="2466622"/>
            <a:ext cx="5495943" cy="1359177"/>
            <a:chOff x="2317243" y="3516848"/>
            <a:chExt cx="9522164" cy="2354883"/>
          </a:xfrm>
        </p:grpSpPr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FFDFE005-B5C1-4774-940A-329F24530A1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14535" y="3516848"/>
              <a:ext cx="3127580" cy="2354883"/>
            </a:xfrm>
            <a:prstGeom prst="rect">
              <a:avLst/>
            </a:prstGeom>
          </p:spPr>
        </p:pic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5E3CB2F7-A843-4009-8406-196F268DFA2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17243" y="3516848"/>
              <a:ext cx="3127580" cy="2354883"/>
            </a:xfrm>
            <a:prstGeom prst="rect">
              <a:avLst/>
            </a:prstGeom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F249920F-2D11-4512-8D27-5624ACF9F79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711827" y="3516848"/>
              <a:ext cx="3127580" cy="2354883"/>
            </a:xfrm>
            <a:prstGeom prst="rect">
              <a:avLst/>
            </a:prstGeom>
          </p:spPr>
        </p:pic>
      </p:grpSp>
      <p:grpSp>
        <p:nvGrpSpPr>
          <p:cNvPr id="13" name="组合 12">
            <a:extLst>
              <a:ext uri="{FF2B5EF4-FFF2-40B4-BE49-F238E27FC236}">
                <a16:creationId xmlns:a16="http://schemas.microsoft.com/office/drawing/2014/main" id="{1F630888-F339-4132-A583-EEA0D00B27F0}"/>
              </a:ext>
            </a:extLst>
          </p:cNvPr>
          <p:cNvGrpSpPr/>
          <p:nvPr/>
        </p:nvGrpSpPr>
        <p:grpSpPr>
          <a:xfrm>
            <a:off x="950577" y="683387"/>
            <a:ext cx="5495943" cy="1656697"/>
            <a:chOff x="2317243" y="3001370"/>
            <a:chExt cx="9522164" cy="2870361"/>
          </a:xfrm>
        </p:grpSpPr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FFDFE005-B5C1-4774-940A-329F24530A1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14535" y="3516848"/>
              <a:ext cx="3127580" cy="2354883"/>
            </a:xfrm>
            <a:prstGeom prst="rect">
              <a:avLst/>
            </a:prstGeom>
          </p:spPr>
        </p:pic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5E3CB2F7-A843-4009-8406-196F268DFA2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17243" y="3516848"/>
              <a:ext cx="3127580" cy="2354883"/>
            </a:xfrm>
            <a:prstGeom prst="rect">
              <a:avLst/>
            </a:prstGeom>
          </p:spPr>
        </p:pic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F249920F-2D11-4512-8D27-5624ACF9F79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711827" y="3516848"/>
              <a:ext cx="3127580" cy="2354883"/>
            </a:xfrm>
            <a:prstGeom prst="rect">
              <a:avLst/>
            </a:prstGeom>
          </p:spPr>
        </p:pic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AF339B8C-FFEF-42C3-8FB3-BFE1EACDDA68}"/>
                </a:ext>
              </a:extLst>
            </p:cNvPr>
            <p:cNvSpPr txBox="1"/>
            <p:nvPr/>
          </p:nvSpPr>
          <p:spPr>
            <a:xfrm>
              <a:off x="6396039" y="3001370"/>
              <a:ext cx="2315786" cy="5332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微软雅黑" panose="020B0503020204020204" pitchFamily="34" charset="-122"/>
                  <a:ea typeface="微软雅黑" panose="020B0503020204020204" pitchFamily="34" charset="-122"/>
                </a:rPr>
                <a:t>VE-Cadherin</a:t>
              </a:r>
              <a:endParaRPr lang="zh-CN" altLang="en-US" sz="1400" b="1" dirty="0">
                <a:latin typeface="微软雅黑" panose="020B0503020204020204" pitchFamily="34" charset="-122"/>
                <a:ea typeface="微软雅黑" panose="020B0503020204020204" pitchFamily="34" charset="-122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D9D81470-6238-48E3-93A0-086EA9468DBD}"/>
                </a:ext>
              </a:extLst>
            </p:cNvPr>
            <p:cNvSpPr txBox="1"/>
            <p:nvPr/>
          </p:nvSpPr>
          <p:spPr>
            <a:xfrm>
              <a:off x="3479153" y="3029702"/>
              <a:ext cx="136456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微软雅黑" panose="020B0503020204020204" pitchFamily="34" charset="-122"/>
                  <a:ea typeface="微软雅黑" panose="020B0503020204020204" pitchFamily="34" charset="-122"/>
                </a:rPr>
                <a:t>DIPA</a:t>
              </a:r>
              <a:endParaRPr lang="zh-CN" altLang="en-US" sz="1400" b="1" dirty="0">
                <a:latin typeface="微软雅黑" panose="020B0503020204020204" pitchFamily="34" charset="-122"/>
                <a:ea typeface="微软雅黑" panose="020B0503020204020204" pitchFamily="34" charset="-122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AFA04BE1-CB70-4B61-94EB-A6B62758EC6C}"/>
                </a:ext>
              </a:extLst>
            </p:cNvPr>
            <p:cNvSpPr txBox="1"/>
            <p:nvPr/>
          </p:nvSpPr>
          <p:spPr>
            <a:xfrm>
              <a:off x="9860813" y="3029702"/>
              <a:ext cx="136456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微软雅黑" panose="020B0503020204020204" pitchFamily="34" charset="-122"/>
                  <a:ea typeface="微软雅黑" panose="020B0503020204020204" pitchFamily="34" charset="-122"/>
                </a:rPr>
                <a:t>Merge</a:t>
              </a:r>
              <a:endParaRPr lang="zh-CN" altLang="en-US" sz="1400" b="1" dirty="0">
                <a:latin typeface="微软雅黑" panose="020B0503020204020204" pitchFamily="34" charset="-122"/>
                <a:ea typeface="微软雅黑" panose="020B0503020204020204" pitchFamily="34" charset="-122"/>
              </a:endParaRPr>
            </a:p>
          </p:txBody>
        </p:sp>
      </p:grpSp>
      <p:sp>
        <p:nvSpPr>
          <p:cNvPr id="20" name="文本框 2"/>
          <p:cNvSpPr txBox="1"/>
          <p:nvPr/>
        </p:nvSpPr>
        <p:spPr>
          <a:xfrm>
            <a:off x="651360" y="287216"/>
            <a:ext cx="9698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4A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 rot="16200000">
            <a:off x="70409" y="4489237"/>
            <a:ext cx="12823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Hep3B-scramble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矩形 21"/>
          <p:cNvSpPr/>
          <p:nvPr/>
        </p:nvSpPr>
        <p:spPr>
          <a:xfrm rot="16200000">
            <a:off x="19692" y="5673737"/>
            <a:ext cx="1375807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Hep3B-CIRC</a:t>
            </a:r>
            <a:endParaRPr lang="zh-CN" altLang="zh-CN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" name="组合 22">
            <a:extLst>
              <a:ext uri="{FF2B5EF4-FFF2-40B4-BE49-F238E27FC236}">
                <a16:creationId xmlns:a16="http://schemas.microsoft.com/office/drawing/2014/main" id="{1F630888-F339-4132-A583-EEA0D00B27F0}"/>
              </a:ext>
            </a:extLst>
          </p:cNvPr>
          <p:cNvGrpSpPr/>
          <p:nvPr/>
        </p:nvGrpSpPr>
        <p:grpSpPr>
          <a:xfrm>
            <a:off x="950577" y="5421327"/>
            <a:ext cx="5495943" cy="1359178"/>
            <a:chOff x="2317244" y="3516848"/>
            <a:chExt cx="9522162" cy="2354883"/>
          </a:xfrm>
        </p:grpSpPr>
        <p:pic>
          <p:nvPicPr>
            <p:cNvPr id="24" name="图片 23">
              <a:extLst>
                <a:ext uri="{FF2B5EF4-FFF2-40B4-BE49-F238E27FC236}">
                  <a16:creationId xmlns:a16="http://schemas.microsoft.com/office/drawing/2014/main" id="{FFDFE005-B5C1-4774-940A-329F24530A1F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14536" y="3516848"/>
              <a:ext cx="3127578" cy="2354883"/>
            </a:xfrm>
            <a:prstGeom prst="rect">
              <a:avLst/>
            </a:prstGeom>
          </p:spPr>
        </p:pic>
        <p:pic>
          <p:nvPicPr>
            <p:cNvPr id="25" name="图片 24">
              <a:extLst>
                <a:ext uri="{FF2B5EF4-FFF2-40B4-BE49-F238E27FC236}">
                  <a16:creationId xmlns:a16="http://schemas.microsoft.com/office/drawing/2014/main" id="{5E3CB2F7-A843-4009-8406-196F268DFA2D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17244" y="3516848"/>
              <a:ext cx="3127578" cy="2354883"/>
            </a:xfrm>
            <a:prstGeom prst="rect">
              <a:avLst/>
            </a:prstGeom>
          </p:spPr>
        </p:pic>
        <p:pic>
          <p:nvPicPr>
            <p:cNvPr id="26" name="图片 25">
              <a:extLst>
                <a:ext uri="{FF2B5EF4-FFF2-40B4-BE49-F238E27FC236}">
                  <a16:creationId xmlns:a16="http://schemas.microsoft.com/office/drawing/2014/main" id="{F249920F-2D11-4512-8D27-5624ACF9F79F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711828" y="3516848"/>
              <a:ext cx="3127578" cy="2354883"/>
            </a:xfrm>
            <a:prstGeom prst="rect">
              <a:avLst/>
            </a:prstGeom>
          </p:spPr>
        </p:pic>
      </p:grpSp>
      <p:grpSp>
        <p:nvGrpSpPr>
          <p:cNvPr id="30" name="组合 29">
            <a:extLst>
              <a:ext uri="{FF2B5EF4-FFF2-40B4-BE49-F238E27FC236}">
                <a16:creationId xmlns:a16="http://schemas.microsoft.com/office/drawing/2014/main" id="{1F630888-F339-4132-A583-EEA0D00B27F0}"/>
              </a:ext>
            </a:extLst>
          </p:cNvPr>
          <p:cNvGrpSpPr/>
          <p:nvPr/>
        </p:nvGrpSpPr>
        <p:grpSpPr>
          <a:xfrm>
            <a:off x="950577" y="3964789"/>
            <a:ext cx="5495943" cy="1359178"/>
            <a:chOff x="2317244" y="3516848"/>
            <a:chExt cx="9522162" cy="2354883"/>
          </a:xfrm>
        </p:grpSpPr>
        <p:pic>
          <p:nvPicPr>
            <p:cNvPr id="31" name="图片 30">
              <a:extLst>
                <a:ext uri="{FF2B5EF4-FFF2-40B4-BE49-F238E27FC236}">
                  <a16:creationId xmlns:a16="http://schemas.microsoft.com/office/drawing/2014/main" id="{FFDFE005-B5C1-4774-940A-329F24530A1F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14536" y="3516848"/>
              <a:ext cx="3127578" cy="2354883"/>
            </a:xfrm>
            <a:prstGeom prst="rect">
              <a:avLst/>
            </a:prstGeom>
          </p:spPr>
        </p:pic>
        <p:pic>
          <p:nvPicPr>
            <p:cNvPr id="32" name="图片 31">
              <a:extLst>
                <a:ext uri="{FF2B5EF4-FFF2-40B4-BE49-F238E27FC236}">
                  <a16:creationId xmlns:a16="http://schemas.microsoft.com/office/drawing/2014/main" id="{5E3CB2F7-A843-4009-8406-196F268DFA2D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17244" y="3516848"/>
              <a:ext cx="3127578" cy="2354883"/>
            </a:xfrm>
            <a:prstGeom prst="rect">
              <a:avLst/>
            </a:prstGeom>
          </p:spPr>
        </p:pic>
        <p:pic>
          <p:nvPicPr>
            <p:cNvPr id="33" name="图片 32">
              <a:extLst>
                <a:ext uri="{FF2B5EF4-FFF2-40B4-BE49-F238E27FC236}">
                  <a16:creationId xmlns:a16="http://schemas.microsoft.com/office/drawing/2014/main" id="{F249920F-2D11-4512-8D27-5624ACF9F79F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711828" y="3516848"/>
              <a:ext cx="3127578" cy="235488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9126910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160" y="1062702"/>
            <a:ext cx="1851660" cy="1393795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88920" y="1062702"/>
            <a:ext cx="1851660" cy="1393795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8680" y="1062701"/>
            <a:ext cx="1851660" cy="1393795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88920" y="2525742"/>
            <a:ext cx="1851660" cy="1393795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160" y="2525741"/>
            <a:ext cx="1851660" cy="1393795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8680" y="2525740"/>
            <a:ext cx="1851660" cy="1393795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160" y="3988780"/>
            <a:ext cx="1851660" cy="1393795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88920" y="3988780"/>
            <a:ext cx="1851660" cy="1393795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8680" y="3988780"/>
            <a:ext cx="1851660" cy="1393795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160" y="5451819"/>
            <a:ext cx="1851660" cy="1393795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88920" y="5451819"/>
            <a:ext cx="1851660" cy="1393795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8680" y="5451819"/>
            <a:ext cx="1851660" cy="1393795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D9D81470-6238-48E3-93A0-086EA9468DBD}"/>
              </a:ext>
            </a:extLst>
          </p:cNvPr>
          <p:cNvSpPr txBox="1"/>
          <p:nvPr/>
        </p:nvSpPr>
        <p:spPr>
          <a:xfrm>
            <a:off x="1547309" y="761619"/>
            <a:ext cx="787592" cy="1776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微软雅黑" panose="020B0503020204020204" pitchFamily="34" charset="-122"/>
                <a:ea typeface="微软雅黑" panose="020B0503020204020204" pitchFamily="34" charset="-122"/>
              </a:rPr>
              <a:t>DIPA</a:t>
            </a:r>
            <a:endParaRPr lang="zh-CN" altLang="en-US" sz="1400" b="1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AFA04BE1-CB70-4B61-94EB-A6B62758EC6C}"/>
              </a:ext>
            </a:extLst>
          </p:cNvPr>
          <p:cNvSpPr txBox="1"/>
          <p:nvPr/>
        </p:nvSpPr>
        <p:spPr>
          <a:xfrm>
            <a:off x="5210714" y="761619"/>
            <a:ext cx="787592" cy="1776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微软雅黑" panose="020B0503020204020204" pitchFamily="34" charset="-122"/>
                <a:ea typeface="微软雅黑" panose="020B0503020204020204" pitchFamily="34" charset="-122"/>
              </a:rPr>
              <a:t>Merge</a:t>
            </a:r>
            <a:endParaRPr lang="zh-CN" altLang="en-US" sz="1400" b="1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17" name="文本框 18">
            <a:extLst>
              <a:ext uri="{FF2B5EF4-FFF2-40B4-BE49-F238E27FC236}">
                <a16:creationId xmlns:a16="http://schemas.microsoft.com/office/drawing/2014/main" id="{AFA04BE1-CB70-4B61-94EB-A6B62758EC6C}"/>
              </a:ext>
            </a:extLst>
          </p:cNvPr>
          <p:cNvSpPr txBox="1"/>
          <p:nvPr/>
        </p:nvSpPr>
        <p:spPr>
          <a:xfrm>
            <a:off x="3379011" y="761618"/>
            <a:ext cx="7875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 smtClean="0">
                <a:latin typeface="微软雅黑" panose="020B0503020204020204" pitchFamily="34" charset="-122"/>
                <a:ea typeface="微软雅黑" panose="020B0503020204020204" pitchFamily="34" charset="-122"/>
              </a:rPr>
              <a:t>ZO-1</a:t>
            </a:r>
            <a:endParaRPr lang="zh-CN" altLang="en-US" sz="1400" b="1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22" name="文本框 21"/>
          <p:cNvSpPr txBox="1"/>
          <p:nvPr/>
        </p:nvSpPr>
        <p:spPr>
          <a:xfrm rot="16200000">
            <a:off x="8088" y="1405978"/>
            <a:ext cx="13990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MHCC97H-siNC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矩形 22"/>
          <p:cNvSpPr/>
          <p:nvPr/>
        </p:nvSpPr>
        <p:spPr>
          <a:xfrm rot="16200000">
            <a:off x="-100044" y="2961842"/>
            <a:ext cx="1615281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MHCC97H-siCIRC</a:t>
            </a:r>
            <a:endParaRPr lang="zh-CN" altLang="zh-CN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 rot="16200000">
            <a:off x="70409" y="4489237"/>
            <a:ext cx="12823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Hep3B-scramble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矩形 24"/>
          <p:cNvSpPr/>
          <p:nvPr/>
        </p:nvSpPr>
        <p:spPr>
          <a:xfrm rot="16200000">
            <a:off x="19692" y="5673737"/>
            <a:ext cx="1375807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Hep3B-CIRC</a:t>
            </a:r>
            <a:endParaRPr lang="zh-CN" altLang="zh-CN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"/>
          <p:cNvSpPr txBox="1"/>
          <p:nvPr/>
        </p:nvSpPr>
        <p:spPr>
          <a:xfrm>
            <a:off x="651360" y="287216"/>
            <a:ext cx="9698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4B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8873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</TotalTime>
  <Words>21</Words>
  <Application>Microsoft Office PowerPoint</Application>
  <PresentationFormat>A4 纸张(210x297 毫米)</PresentationFormat>
  <Paragraphs>21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0" baseType="lpstr">
      <vt:lpstr>等线</vt:lpstr>
      <vt:lpstr>等线 Light</vt:lpstr>
      <vt:lpstr>微软雅黑</vt:lpstr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homas11</dc:creator>
  <cp:lastModifiedBy>thomas11</cp:lastModifiedBy>
  <cp:revision>15</cp:revision>
  <dcterms:created xsi:type="dcterms:W3CDTF">2019-12-08T09:15:13Z</dcterms:created>
  <dcterms:modified xsi:type="dcterms:W3CDTF">2019-12-08T09:39:33Z</dcterms:modified>
</cp:coreProperties>
</file>